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25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 smtClean="0"/>
              <a:t>Alcím mintájának szerkesztése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19273-A21D-485D-99B6-DD78EDF3A55C}" type="datetimeFigureOut">
              <a:rPr lang="hu-HU" smtClean="0"/>
              <a:t>2021.06.16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D3ABD-7259-41D6-8D09-5EB2B0B4BCA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9268677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19273-A21D-485D-99B6-DD78EDF3A55C}" type="datetimeFigureOut">
              <a:rPr lang="hu-HU" smtClean="0"/>
              <a:t>2021.06.16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D3ABD-7259-41D6-8D09-5EB2B0B4BCA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484586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19273-A21D-485D-99B6-DD78EDF3A55C}" type="datetimeFigureOut">
              <a:rPr lang="hu-HU" smtClean="0"/>
              <a:t>2021.06.16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D3ABD-7259-41D6-8D09-5EB2B0B4BCA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2583133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19273-A21D-485D-99B6-DD78EDF3A55C}" type="datetimeFigureOut">
              <a:rPr lang="hu-HU" smtClean="0"/>
              <a:t>2021.06.16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D3ABD-7259-41D6-8D09-5EB2B0B4BCA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434679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19273-A21D-485D-99B6-DD78EDF3A55C}" type="datetimeFigureOut">
              <a:rPr lang="hu-HU" smtClean="0"/>
              <a:t>2021.06.16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D3ABD-7259-41D6-8D09-5EB2B0B4BCA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359467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19273-A21D-485D-99B6-DD78EDF3A55C}" type="datetimeFigureOut">
              <a:rPr lang="hu-HU" smtClean="0"/>
              <a:t>2021.06.16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D3ABD-7259-41D6-8D09-5EB2B0B4BCA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31773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19273-A21D-485D-99B6-DD78EDF3A55C}" type="datetimeFigureOut">
              <a:rPr lang="hu-HU" smtClean="0"/>
              <a:t>2021.06.16.</a:t>
            </a:fld>
            <a:endParaRPr lang="hu-HU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D3ABD-7259-41D6-8D09-5EB2B0B4BCA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500815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19273-A21D-485D-99B6-DD78EDF3A55C}" type="datetimeFigureOut">
              <a:rPr lang="hu-HU" smtClean="0"/>
              <a:t>2021.06.16.</a:t>
            </a:fld>
            <a:endParaRPr lang="hu-HU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D3ABD-7259-41D6-8D09-5EB2B0B4BCA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600012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19273-A21D-485D-99B6-DD78EDF3A55C}" type="datetimeFigureOut">
              <a:rPr lang="hu-HU" smtClean="0"/>
              <a:t>2021.06.16.</a:t>
            </a:fld>
            <a:endParaRPr lang="hu-HU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D3ABD-7259-41D6-8D09-5EB2B0B4BCA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85854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19273-A21D-485D-99B6-DD78EDF3A55C}" type="datetimeFigureOut">
              <a:rPr lang="hu-HU" smtClean="0"/>
              <a:t>2021.06.16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D3ABD-7259-41D6-8D09-5EB2B0B4BCA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397520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19273-A21D-485D-99B6-DD78EDF3A55C}" type="datetimeFigureOut">
              <a:rPr lang="hu-HU" smtClean="0"/>
              <a:t>2021.06.16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D3ABD-7259-41D6-8D09-5EB2B0B4BCA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820984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519273-A21D-485D-99B6-DD78EDF3A55C}" type="datetimeFigureOut">
              <a:rPr lang="hu-HU" smtClean="0"/>
              <a:t>2021.06.16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9D3ABD-7259-41D6-8D09-5EB2B0B4BCA8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337338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Csoportba foglalás 3"/>
          <p:cNvGrpSpPr/>
          <p:nvPr/>
        </p:nvGrpSpPr>
        <p:grpSpPr>
          <a:xfrm>
            <a:off x="1329847" y="1089822"/>
            <a:ext cx="8921937" cy="3771653"/>
            <a:chOff x="1329847" y="1089822"/>
            <a:chExt cx="8921937" cy="3771653"/>
          </a:xfrm>
        </p:grpSpPr>
        <p:sp>
          <p:nvSpPr>
            <p:cNvPr id="205" name="Lekerekített téglalap 204"/>
            <p:cNvSpPr/>
            <p:nvPr/>
          </p:nvSpPr>
          <p:spPr>
            <a:xfrm>
              <a:off x="7577354" y="3500874"/>
              <a:ext cx="1114886" cy="363942"/>
            </a:xfrm>
            <a:prstGeom prst="roundRect">
              <a:avLst/>
            </a:prstGeom>
            <a:solidFill>
              <a:schemeClr val="bg1">
                <a:lumMod val="95000"/>
              </a:schemeClr>
            </a:solidFill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762"/>
            </a:p>
          </p:txBody>
        </p:sp>
        <p:sp>
          <p:nvSpPr>
            <p:cNvPr id="49" name="Szövegdoboz 48"/>
            <p:cNvSpPr txBox="1"/>
            <p:nvPr/>
          </p:nvSpPr>
          <p:spPr>
            <a:xfrm>
              <a:off x="2300373" y="2215052"/>
              <a:ext cx="721972" cy="209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76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thanofuran</a:t>
              </a:r>
              <a:endParaRPr lang="hu-HU" sz="76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0" name="Csoportba foglalás 49"/>
            <p:cNvGrpSpPr/>
            <p:nvPr/>
          </p:nvGrpSpPr>
          <p:grpSpPr>
            <a:xfrm>
              <a:off x="3169866" y="2126034"/>
              <a:ext cx="1220771" cy="445492"/>
              <a:chOff x="7162763" y="5576022"/>
              <a:chExt cx="2563336" cy="935430"/>
            </a:xfrm>
          </p:grpSpPr>
          <p:sp>
            <p:nvSpPr>
              <p:cNvPr id="51" name="Lekerekített téglalap 50"/>
              <p:cNvSpPr/>
              <p:nvPr/>
            </p:nvSpPr>
            <p:spPr>
              <a:xfrm>
                <a:off x="7194885" y="5576022"/>
                <a:ext cx="2341002" cy="813969"/>
              </a:xfrm>
              <a:prstGeom prst="roundRect">
                <a:avLst/>
              </a:prstGeom>
              <a:solidFill>
                <a:schemeClr val="bg1">
                  <a:lumMod val="95000"/>
                </a:schemeClr>
              </a:solidFill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762"/>
              </a:p>
            </p:txBody>
          </p:sp>
          <p:sp>
            <p:nvSpPr>
              <p:cNvPr id="52" name="Szövegdoboz 51"/>
              <p:cNvSpPr txBox="1"/>
              <p:nvPr/>
            </p:nvSpPr>
            <p:spPr>
              <a:xfrm>
                <a:off x="7162763" y="5578817"/>
                <a:ext cx="2563336" cy="9326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u-HU" sz="762" b="1" u="sng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md</a:t>
                </a:r>
                <a:endParaRPr lang="hu-HU" sz="762" b="1" u="sng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hu-HU" sz="762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rmylmethanofuran</a:t>
                </a:r>
                <a:r>
                  <a:rPr lang="hu-HU" sz="762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hu-HU" sz="762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hydrogenase</a:t>
                </a:r>
                <a:endParaRPr lang="hu-HU" sz="762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3" name="Szövegdoboz 52"/>
            <p:cNvSpPr txBox="1"/>
            <p:nvPr/>
          </p:nvSpPr>
          <p:spPr>
            <a:xfrm>
              <a:off x="4292816" y="2171561"/>
              <a:ext cx="806126" cy="3268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76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ormil-methanofuran</a:t>
              </a:r>
              <a:endParaRPr lang="hu-HU" sz="76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Szövegdoboz 53"/>
            <p:cNvSpPr txBox="1"/>
            <p:nvPr/>
          </p:nvSpPr>
          <p:spPr>
            <a:xfrm>
              <a:off x="2802652" y="1717965"/>
              <a:ext cx="5476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</a:t>
              </a:r>
              <a:r>
                <a:rPr lang="hu-HU" sz="1400" baseline="-25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hu-HU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5" name="Csoportba foglalás 54"/>
            <p:cNvGrpSpPr/>
            <p:nvPr/>
          </p:nvGrpSpPr>
          <p:grpSpPr>
            <a:xfrm>
              <a:off x="5027432" y="2071117"/>
              <a:ext cx="1269340" cy="561436"/>
              <a:chOff x="7113008" y="5612448"/>
              <a:chExt cx="2491213" cy="918626"/>
            </a:xfrm>
          </p:grpSpPr>
          <p:sp>
            <p:nvSpPr>
              <p:cNvPr id="56" name="Lekerekített téglalap 55"/>
              <p:cNvSpPr/>
              <p:nvPr/>
            </p:nvSpPr>
            <p:spPr>
              <a:xfrm>
                <a:off x="7194885" y="5643154"/>
                <a:ext cx="2341002" cy="811282"/>
              </a:xfrm>
              <a:prstGeom prst="roundRect">
                <a:avLst/>
              </a:prstGeom>
              <a:solidFill>
                <a:schemeClr val="bg1">
                  <a:lumMod val="95000"/>
                </a:schemeClr>
              </a:solidFill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762"/>
              </a:p>
            </p:txBody>
          </p:sp>
          <p:sp>
            <p:nvSpPr>
              <p:cNvPr id="57" name="Szövegdoboz 56"/>
              <p:cNvSpPr txBox="1"/>
              <p:nvPr/>
            </p:nvSpPr>
            <p:spPr>
              <a:xfrm>
                <a:off x="7113008" y="5612448"/>
                <a:ext cx="2491213" cy="9186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u-HU" sz="762" b="1" u="sng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tr</a:t>
                </a:r>
                <a:endParaRPr lang="hu-HU" sz="762" b="1" u="sng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hu-HU" sz="762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rmylmethanofuran</a:t>
                </a:r>
                <a:r>
                  <a:rPr lang="hu-HU" sz="762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-</a:t>
                </a:r>
                <a:r>
                  <a:rPr lang="hu-HU" sz="762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etrahydromethanopterin</a:t>
                </a:r>
                <a:r>
                  <a:rPr lang="hu-HU" sz="762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N-</a:t>
                </a:r>
                <a:r>
                  <a:rPr lang="hu-HU" sz="762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rmyltransferase</a:t>
                </a:r>
                <a:endParaRPr lang="hu-HU" sz="762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8" name="Szövegdoboz 57"/>
            <p:cNvSpPr txBox="1"/>
            <p:nvPr/>
          </p:nvSpPr>
          <p:spPr>
            <a:xfrm>
              <a:off x="6346612" y="2221883"/>
              <a:ext cx="1144291" cy="3268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76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5-formyl-tetrahydromethanopterin</a:t>
              </a:r>
            </a:p>
          </p:txBody>
        </p:sp>
        <p:grpSp>
          <p:nvGrpSpPr>
            <p:cNvPr id="63" name="Csoportba foglalás 62"/>
            <p:cNvGrpSpPr/>
            <p:nvPr/>
          </p:nvGrpSpPr>
          <p:grpSpPr>
            <a:xfrm>
              <a:off x="7525196" y="2131081"/>
              <a:ext cx="1220771" cy="444161"/>
              <a:chOff x="7464064" y="5592922"/>
              <a:chExt cx="2563336" cy="932636"/>
            </a:xfrm>
          </p:grpSpPr>
          <p:sp>
            <p:nvSpPr>
              <p:cNvPr id="64" name="Lekerekített téglalap 63"/>
              <p:cNvSpPr/>
              <p:nvPr/>
            </p:nvSpPr>
            <p:spPr>
              <a:xfrm>
                <a:off x="7600416" y="5616520"/>
                <a:ext cx="2341002" cy="856229"/>
              </a:xfrm>
              <a:prstGeom prst="roundRect">
                <a:avLst/>
              </a:prstGeom>
              <a:solidFill>
                <a:schemeClr val="bg1">
                  <a:lumMod val="95000"/>
                </a:schemeClr>
              </a:solidFill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762"/>
              </a:p>
            </p:txBody>
          </p:sp>
          <p:sp>
            <p:nvSpPr>
              <p:cNvPr id="65" name="Szövegdoboz 64"/>
              <p:cNvSpPr txBox="1"/>
              <p:nvPr/>
            </p:nvSpPr>
            <p:spPr>
              <a:xfrm>
                <a:off x="7464064" y="5592922"/>
                <a:ext cx="2563336" cy="9326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u-HU" sz="762" b="1" u="sng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ch</a:t>
                </a:r>
                <a:endParaRPr lang="hu-HU" sz="762" b="1" u="sng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hu-HU" sz="762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thenyltetrahydromethanopterin</a:t>
                </a:r>
                <a:r>
                  <a:rPr lang="hu-HU" sz="762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hu-HU" sz="762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yclohydrolase</a:t>
                </a:r>
                <a:endParaRPr lang="hu-HU" sz="762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6" name="Szövegdoboz 65"/>
            <p:cNvSpPr txBox="1"/>
            <p:nvPr/>
          </p:nvSpPr>
          <p:spPr>
            <a:xfrm>
              <a:off x="8803092" y="2243232"/>
              <a:ext cx="1166544" cy="3268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76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,10-methylene-tetrahydromethanopterin</a:t>
              </a:r>
            </a:p>
          </p:txBody>
        </p:sp>
        <p:grpSp>
          <p:nvGrpSpPr>
            <p:cNvPr id="70" name="Csoportba foglalás 69"/>
            <p:cNvGrpSpPr/>
            <p:nvPr/>
          </p:nvGrpSpPr>
          <p:grpSpPr>
            <a:xfrm>
              <a:off x="8732099" y="2736217"/>
              <a:ext cx="1291944" cy="561436"/>
              <a:chOff x="7525320" y="5627066"/>
              <a:chExt cx="2549127" cy="918629"/>
            </a:xfrm>
          </p:grpSpPr>
          <p:sp>
            <p:nvSpPr>
              <p:cNvPr id="71" name="Lekerekített téglalap 70"/>
              <p:cNvSpPr/>
              <p:nvPr/>
            </p:nvSpPr>
            <p:spPr>
              <a:xfrm>
                <a:off x="7626096" y="5650275"/>
                <a:ext cx="2341002" cy="807231"/>
              </a:xfrm>
              <a:prstGeom prst="roundRect">
                <a:avLst/>
              </a:prstGeom>
              <a:solidFill>
                <a:schemeClr val="bg1">
                  <a:lumMod val="95000"/>
                </a:schemeClr>
              </a:solidFill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762"/>
              </a:p>
            </p:txBody>
          </p:sp>
          <p:sp>
            <p:nvSpPr>
              <p:cNvPr id="72" name="Szövegdoboz 71"/>
              <p:cNvSpPr txBox="1"/>
              <p:nvPr/>
            </p:nvSpPr>
            <p:spPr>
              <a:xfrm>
                <a:off x="7525320" y="5627066"/>
                <a:ext cx="2549127" cy="9186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u-HU" sz="762" b="1" u="sng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tr</a:t>
                </a:r>
                <a:endParaRPr lang="hu-HU" sz="762" b="1" u="sng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hu-HU" sz="762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,10-methylene -</a:t>
                </a:r>
                <a:r>
                  <a:rPr lang="hu-HU" sz="762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etrahydromethanopterin</a:t>
                </a:r>
                <a:r>
                  <a:rPr lang="hu-HU" sz="762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hu-HU" sz="762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ductase</a:t>
                </a:r>
                <a:endParaRPr lang="hu-HU" sz="762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3" name="Szövegdoboz 72"/>
            <p:cNvSpPr txBox="1"/>
            <p:nvPr/>
          </p:nvSpPr>
          <p:spPr>
            <a:xfrm>
              <a:off x="7545070" y="2758031"/>
              <a:ext cx="1161492" cy="4441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76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-methyl-tetrahydromethanopterin(S)PT</a:t>
              </a:r>
            </a:p>
          </p:txBody>
        </p:sp>
        <p:grpSp>
          <p:nvGrpSpPr>
            <p:cNvPr id="74" name="Csoportba foglalás 73"/>
            <p:cNvGrpSpPr/>
            <p:nvPr/>
          </p:nvGrpSpPr>
          <p:grpSpPr>
            <a:xfrm>
              <a:off x="6270132" y="2750416"/>
              <a:ext cx="1220771" cy="444161"/>
              <a:chOff x="7132994" y="5530543"/>
              <a:chExt cx="2563336" cy="932636"/>
            </a:xfrm>
          </p:grpSpPr>
          <p:sp>
            <p:nvSpPr>
              <p:cNvPr id="75" name="Lekerekített téglalap 74"/>
              <p:cNvSpPr/>
              <p:nvPr/>
            </p:nvSpPr>
            <p:spPr>
              <a:xfrm>
                <a:off x="7219169" y="5584726"/>
                <a:ext cx="2341002" cy="786311"/>
              </a:xfrm>
              <a:prstGeom prst="roundRect">
                <a:avLst/>
              </a:prstGeom>
              <a:solidFill>
                <a:schemeClr val="bg1">
                  <a:lumMod val="95000"/>
                </a:schemeClr>
              </a:solidFill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762"/>
              </a:p>
            </p:txBody>
          </p:sp>
          <p:sp>
            <p:nvSpPr>
              <p:cNvPr id="76" name="Szövegdoboz 75"/>
              <p:cNvSpPr txBox="1"/>
              <p:nvPr/>
            </p:nvSpPr>
            <p:spPr>
              <a:xfrm>
                <a:off x="7132994" y="5530543"/>
                <a:ext cx="2563336" cy="9326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u-HU" sz="762" b="1" u="sng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tr</a:t>
                </a:r>
                <a:endParaRPr lang="hu-HU" sz="762" b="1" u="sng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hu-HU" sz="762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etrahydromethanopterin</a:t>
                </a:r>
                <a:r>
                  <a:rPr lang="hu-HU" sz="762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-</a:t>
                </a:r>
                <a:r>
                  <a:rPr lang="hu-HU" sz="762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thyltransferase</a:t>
                </a:r>
                <a:endParaRPr lang="hu-HU" sz="762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7" name="Szövegdoboz 76"/>
            <p:cNvSpPr txBox="1"/>
            <p:nvPr/>
          </p:nvSpPr>
          <p:spPr>
            <a:xfrm>
              <a:off x="5556973" y="2812665"/>
              <a:ext cx="713701" cy="3268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76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thyl-coenzyme</a:t>
              </a:r>
              <a:r>
                <a:rPr lang="hu-HU" sz="76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</a:t>
              </a:r>
            </a:p>
          </p:txBody>
        </p:sp>
        <p:grpSp>
          <p:nvGrpSpPr>
            <p:cNvPr id="78" name="Csoportba foglalás 77"/>
            <p:cNvGrpSpPr/>
            <p:nvPr/>
          </p:nvGrpSpPr>
          <p:grpSpPr>
            <a:xfrm>
              <a:off x="4357846" y="2731947"/>
              <a:ext cx="1270094" cy="444161"/>
              <a:chOff x="7096457" y="5492168"/>
              <a:chExt cx="2666904" cy="932634"/>
            </a:xfrm>
          </p:grpSpPr>
          <p:sp>
            <p:nvSpPr>
              <p:cNvPr id="79" name="Lekerekített téglalap 78"/>
              <p:cNvSpPr/>
              <p:nvPr/>
            </p:nvSpPr>
            <p:spPr>
              <a:xfrm>
                <a:off x="7204710" y="5552822"/>
                <a:ext cx="2341002" cy="764193"/>
              </a:xfrm>
              <a:prstGeom prst="roundRect">
                <a:avLst/>
              </a:prstGeom>
              <a:solidFill>
                <a:schemeClr val="bg1">
                  <a:lumMod val="95000"/>
                </a:schemeClr>
              </a:solidFill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762"/>
              </a:p>
            </p:txBody>
          </p:sp>
          <p:sp>
            <p:nvSpPr>
              <p:cNvPr id="80" name="Szövegdoboz 79"/>
              <p:cNvSpPr txBox="1"/>
              <p:nvPr/>
            </p:nvSpPr>
            <p:spPr>
              <a:xfrm>
                <a:off x="7096457" y="5492168"/>
                <a:ext cx="2666904" cy="9326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u-HU" sz="762" b="1" u="sng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cr</a:t>
                </a:r>
                <a:endParaRPr lang="hu-HU" sz="762" b="1" u="sng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hu-HU" sz="762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thyl-coenzyme</a:t>
                </a:r>
                <a:r>
                  <a:rPr lang="hu-HU" sz="762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 </a:t>
                </a:r>
                <a:r>
                  <a:rPr lang="hu-HU" sz="762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ductase</a:t>
                </a:r>
                <a:endParaRPr lang="hu-HU" sz="762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81" name="Szövegdoboz 80"/>
            <p:cNvSpPr txBox="1"/>
            <p:nvPr/>
          </p:nvSpPr>
          <p:spPr>
            <a:xfrm>
              <a:off x="3464762" y="2826276"/>
              <a:ext cx="783338" cy="3268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76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enzyme</a:t>
              </a:r>
              <a:r>
                <a:rPr lang="hu-HU" sz="76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 S-S-</a:t>
              </a:r>
              <a:r>
                <a:rPr lang="hu-HU" sz="76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B</a:t>
              </a:r>
              <a:endParaRPr lang="hu-HU" sz="76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Szövegdoboz 81"/>
            <p:cNvSpPr txBox="1"/>
            <p:nvPr/>
          </p:nvSpPr>
          <p:spPr>
            <a:xfrm>
              <a:off x="3565586" y="3208829"/>
              <a:ext cx="67871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</a:t>
              </a:r>
              <a:r>
                <a:rPr lang="hu-HU" sz="2000" baseline="-25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hu-HU" sz="20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3" name="Csoportba foglalás 82"/>
            <p:cNvGrpSpPr/>
            <p:nvPr/>
          </p:nvGrpSpPr>
          <p:grpSpPr>
            <a:xfrm>
              <a:off x="2218454" y="2781415"/>
              <a:ext cx="1220771" cy="608147"/>
              <a:chOff x="7113966" y="5632597"/>
              <a:chExt cx="2563336" cy="932636"/>
            </a:xfrm>
          </p:grpSpPr>
          <p:sp>
            <p:nvSpPr>
              <p:cNvPr id="84" name="Lekerekített téglalap 83"/>
              <p:cNvSpPr/>
              <p:nvPr/>
            </p:nvSpPr>
            <p:spPr>
              <a:xfrm>
                <a:off x="7194885" y="5643154"/>
                <a:ext cx="2341002" cy="637329"/>
              </a:xfrm>
              <a:prstGeom prst="roundRect">
                <a:avLst/>
              </a:prstGeom>
              <a:solidFill>
                <a:schemeClr val="bg1">
                  <a:lumMod val="95000"/>
                </a:schemeClr>
              </a:solidFill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762"/>
              </a:p>
            </p:txBody>
          </p:sp>
          <p:sp>
            <p:nvSpPr>
              <p:cNvPr id="85" name="Szövegdoboz 84"/>
              <p:cNvSpPr txBox="1"/>
              <p:nvPr/>
            </p:nvSpPr>
            <p:spPr>
              <a:xfrm>
                <a:off x="7113966" y="5632597"/>
                <a:ext cx="2563336" cy="9326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u-HU" sz="762" b="1" u="sng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dr</a:t>
                </a:r>
                <a:endParaRPr lang="hu-HU" sz="762" b="1" u="sng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hu-HU" sz="762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terodisulfide</a:t>
                </a:r>
                <a:r>
                  <a:rPr lang="hu-HU" sz="762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hu-HU" sz="762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ductase</a:t>
                </a:r>
                <a:endParaRPr lang="hu-HU" sz="762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86" name="Egyenes összekötő nyíllal 85"/>
            <p:cNvCxnSpPr/>
            <p:nvPr/>
          </p:nvCxnSpPr>
          <p:spPr>
            <a:xfrm>
              <a:off x="4352992" y="2307795"/>
              <a:ext cx="111451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Egyenes összekötő nyíllal 86"/>
            <p:cNvCxnSpPr/>
            <p:nvPr/>
          </p:nvCxnSpPr>
          <p:spPr>
            <a:xfrm>
              <a:off x="4988481" y="2323209"/>
              <a:ext cx="111451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Egyenes összekötő nyíllal 87"/>
            <p:cNvCxnSpPr/>
            <p:nvPr/>
          </p:nvCxnSpPr>
          <p:spPr>
            <a:xfrm>
              <a:off x="6282494" y="2352918"/>
              <a:ext cx="111451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Egyenes összekötő nyíllal 88"/>
            <p:cNvCxnSpPr/>
            <p:nvPr/>
          </p:nvCxnSpPr>
          <p:spPr>
            <a:xfrm>
              <a:off x="7411710" y="2361130"/>
              <a:ext cx="111451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Egyenes összekötő nyíllal 89"/>
            <p:cNvCxnSpPr/>
            <p:nvPr/>
          </p:nvCxnSpPr>
          <p:spPr>
            <a:xfrm>
              <a:off x="8733581" y="2361130"/>
              <a:ext cx="111451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Egyenes összekötő nyíllal 90"/>
            <p:cNvCxnSpPr/>
            <p:nvPr/>
          </p:nvCxnSpPr>
          <p:spPr>
            <a:xfrm>
              <a:off x="9331325" y="2574156"/>
              <a:ext cx="0" cy="10223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Egyenes összekötő nyíllal 96"/>
            <p:cNvCxnSpPr/>
            <p:nvPr/>
          </p:nvCxnSpPr>
          <p:spPr>
            <a:xfrm flipH="1">
              <a:off x="8620895" y="2992322"/>
              <a:ext cx="12423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Egyenes összekötő nyíllal 99"/>
            <p:cNvCxnSpPr/>
            <p:nvPr/>
          </p:nvCxnSpPr>
          <p:spPr>
            <a:xfrm flipH="1">
              <a:off x="7465903" y="2980112"/>
              <a:ext cx="12423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Egyenes összekötő nyíllal 100"/>
            <p:cNvCxnSpPr/>
            <p:nvPr/>
          </p:nvCxnSpPr>
          <p:spPr>
            <a:xfrm flipH="1">
              <a:off x="6142714" y="2940810"/>
              <a:ext cx="12423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Egyenes összekötő nyíllal 101"/>
            <p:cNvCxnSpPr/>
            <p:nvPr/>
          </p:nvCxnSpPr>
          <p:spPr>
            <a:xfrm flipH="1">
              <a:off x="5561041" y="2928565"/>
              <a:ext cx="12423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Egyenes összekötő nyíllal 102"/>
            <p:cNvCxnSpPr/>
            <p:nvPr/>
          </p:nvCxnSpPr>
          <p:spPr>
            <a:xfrm flipH="1">
              <a:off x="4244813" y="2958883"/>
              <a:ext cx="12423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Egyenes összekötő nyíllal 103"/>
            <p:cNvCxnSpPr/>
            <p:nvPr/>
          </p:nvCxnSpPr>
          <p:spPr>
            <a:xfrm flipH="1">
              <a:off x="3402647" y="2992322"/>
              <a:ext cx="12423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Egyenes összekötő nyíllal 104"/>
            <p:cNvCxnSpPr/>
            <p:nvPr/>
          </p:nvCxnSpPr>
          <p:spPr>
            <a:xfrm flipH="1">
              <a:off x="4160448" y="3028770"/>
              <a:ext cx="208596" cy="2073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Egyenes összekötő nyíllal 122"/>
            <p:cNvCxnSpPr/>
            <p:nvPr/>
          </p:nvCxnSpPr>
          <p:spPr>
            <a:xfrm>
              <a:off x="3020770" y="2308866"/>
              <a:ext cx="111451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Egyenes összekötő nyíllal 123"/>
            <p:cNvCxnSpPr/>
            <p:nvPr/>
          </p:nvCxnSpPr>
          <p:spPr>
            <a:xfrm>
              <a:off x="3060885" y="1962468"/>
              <a:ext cx="3288" cy="246106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Egyenes összekötő nyíllal 128"/>
            <p:cNvCxnSpPr/>
            <p:nvPr/>
          </p:nvCxnSpPr>
          <p:spPr>
            <a:xfrm flipH="1">
              <a:off x="2029978" y="2997078"/>
              <a:ext cx="12423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Szövegdoboz 129"/>
            <p:cNvSpPr txBox="1"/>
            <p:nvPr/>
          </p:nvSpPr>
          <p:spPr>
            <a:xfrm>
              <a:off x="1329847" y="2881945"/>
              <a:ext cx="762246" cy="209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76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enzyme</a:t>
              </a:r>
              <a:r>
                <a:rPr lang="hu-HU" sz="76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</a:t>
              </a:r>
            </a:p>
          </p:txBody>
        </p:sp>
        <p:sp>
          <p:nvSpPr>
            <p:cNvPr id="134" name="Szövegdoboz 133"/>
            <p:cNvSpPr txBox="1"/>
            <p:nvPr/>
          </p:nvSpPr>
          <p:spPr>
            <a:xfrm>
              <a:off x="4547725" y="1089822"/>
              <a:ext cx="209583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2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thanogenesis</a:t>
              </a:r>
              <a:endParaRPr lang="hu-HU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Lekerekített téglalap 167"/>
            <p:cNvSpPr/>
            <p:nvPr/>
          </p:nvSpPr>
          <p:spPr>
            <a:xfrm>
              <a:off x="1329847" y="1626035"/>
              <a:ext cx="8921937" cy="3235440"/>
            </a:xfrm>
            <a:prstGeom prst="roundRect">
              <a:avLst/>
            </a:pr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57"/>
            </a:p>
          </p:txBody>
        </p:sp>
        <p:sp>
          <p:nvSpPr>
            <p:cNvPr id="199" name="Szövegdoboz 198"/>
            <p:cNvSpPr txBox="1"/>
            <p:nvPr/>
          </p:nvSpPr>
          <p:spPr>
            <a:xfrm>
              <a:off x="7523161" y="3477619"/>
              <a:ext cx="1220771" cy="4441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762" b="1" u="sng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dh</a:t>
              </a:r>
              <a:endParaRPr lang="hu-HU" sz="762" b="1" u="sng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hu-HU" sz="762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cetyl-CoA</a:t>
              </a:r>
              <a:r>
                <a:rPr lang="hu-HU" sz="76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hu-HU" sz="762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ecarbonylase</a:t>
              </a:r>
              <a:r>
                <a:rPr lang="hu-HU" sz="76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</a:t>
              </a:r>
              <a:r>
                <a:rPr lang="hu-HU" sz="762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ynthase</a:t>
              </a:r>
              <a:endParaRPr lang="hu-HU" sz="76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" name="Szövegdoboz 205"/>
            <p:cNvSpPr txBox="1"/>
            <p:nvPr/>
          </p:nvSpPr>
          <p:spPr>
            <a:xfrm>
              <a:off x="7714363" y="4173047"/>
              <a:ext cx="153773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2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cetyl-CoA</a:t>
              </a:r>
              <a:endParaRPr lang="hu-HU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08" name="Csoportba foglalás 207"/>
            <p:cNvGrpSpPr/>
            <p:nvPr/>
          </p:nvGrpSpPr>
          <p:grpSpPr>
            <a:xfrm>
              <a:off x="6270132" y="4172375"/>
              <a:ext cx="1220771" cy="326884"/>
              <a:chOff x="7113966" y="5632597"/>
              <a:chExt cx="2563336" cy="686381"/>
            </a:xfrm>
          </p:grpSpPr>
          <p:sp>
            <p:nvSpPr>
              <p:cNvPr id="209" name="Lekerekített téglalap 208"/>
              <p:cNvSpPr/>
              <p:nvPr/>
            </p:nvSpPr>
            <p:spPr>
              <a:xfrm>
                <a:off x="7194885" y="5643154"/>
                <a:ext cx="2341002" cy="637329"/>
              </a:xfrm>
              <a:prstGeom prst="roundRect">
                <a:avLst/>
              </a:prstGeom>
              <a:solidFill>
                <a:schemeClr val="bg1">
                  <a:lumMod val="95000"/>
                </a:schemeClr>
              </a:solidFill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762"/>
              </a:p>
            </p:txBody>
          </p:sp>
          <p:sp>
            <p:nvSpPr>
              <p:cNvPr id="210" name="Szövegdoboz 209"/>
              <p:cNvSpPr txBox="1"/>
              <p:nvPr/>
            </p:nvSpPr>
            <p:spPr>
              <a:xfrm>
                <a:off x="7113966" y="5632597"/>
                <a:ext cx="2563336" cy="6863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u-HU" sz="762" b="1" u="sng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s</a:t>
                </a:r>
                <a:endParaRPr lang="hu-HU" sz="762" b="1" u="sng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hu-HU" sz="762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etyl-CoA</a:t>
                </a:r>
                <a:r>
                  <a:rPr lang="hu-HU" sz="762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hu-HU" sz="762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ynthetase</a:t>
                </a:r>
                <a:endParaRPr lang="hu-HU" sz="762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212" name="Egyenes összekötő nyíllal 211"/>
            <p:cNvCxnSpPr/>
            <p:nvPr/>
          </p:nvCxnSpPr>
          <p:spPr>
            <a:xfrm flipV="1">
              <a:off x="8113853" y="3262837"/>
              <a:ext cx="0" cy="12672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3" name="Egyenes összekötő nyíllal 212"/>
            <p:cNvCxnSpPr/>
            <p:nvPr/>
          </p:nvCxnSpPr>
          <p:spPr>
            <a:xfrm flipV="1">
              <a:off x="8125845" y="4003159"/>
              <a:ext cx="0" cy="12672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5" name="Egyenes összekötő nyíllal 214"/>
            <p:cNvCxnSpPr/>
            <p:nvPr/>
          </p:nvCxnSpPr>
          <p:spPr>
            <a:xfrm flipH="1">
              <a:off x="7590133" y="4327074"/>
              <a:ext cx="12423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6" name="Egyenes összekötő nyíllal 215"/>
            <p:cNvCxnSpPr/>
            <p:nvPr/>
          </p:nvCxnSpPr>
          <p:spPr>
            <a:xfrm flipH="1">
              <a:off x="6128328" y="4327074"/>
              <a:ext cx="12423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7" name="Szövegdoboz 216"/>
            <p:cNvSpPr txBox="1"/>
            <p:nvPr/>
          </p:nvSpPr>
          <p:spPr>
            <a:xfrm>
              <a:off x="5688282" y="4231006"/>
              <a:ext cx="500896" cy="209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76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cetate</a:t>
              </a:r>
              <a:endParaRPr lang="hu-HU" sz="76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18" name="Csoportba foglalás 217"/>
            <p:cNvGrpSpPr/>
            <p:nvPr/>
          </p:nvGrpSpPr>
          <p:grpSpPr>
            <a:xfrm>
              <a:off x="6217499" y="3477621"/>
              <a:ext cx="1232336" cy="444161"/>
              <a:chOff x="7089681" y="5632597"/>
              <a:chExt cx="2587621" cy="717357"/>
            </a:xfrm>
          </p:grpSpPr>
          <p:sp>
            <p:nvSpPr>
              <p:cNvPr id="219" name="Lekerekített téglalap 218"/>
              <p:cNvSpPr/>
              <p:nvPr/>
            </p:nvSpPr>
            <p:spPr>
              <a:xfrm>
                <a:off x="7194885" y="5643154"/>
                <a:ext cx="2341002" cy="637329"/>
              </a:xfrm>
              <a:prstGeom prst="roundRect">
                <a:avLst/>
              </a:prstGeom>
              <a:solidFill>
                <a:schemeClr val="bg1">
                  <a:lumMod val="95000"/>
                </a:schemeClr>
              </a:solidFill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762"/>
              </a:p>
            </p:txBody>
          </p:sp>
          <p:sp>
            <p:nvSpPr>
              <p:cNvPr id="220" name="Szövegdoboz 219"/>
              <p:cNvSpPr txBox="1"/>
              <p:nvPr/>
            </p:nvSpPr>
            <p:spPr>
              <a:xfrm>
                <a:off x="7089681" y="5632597"/>
                <a:ext cx="2587621" cy="7173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u-HU" sz="762" b="1" u="sng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ta</a:t>
                </a:r>
                <a:endParaRPr lang="hu-HU" sz="762" b="1" u="sng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hu-HU" sz="762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osphate</a:t>
                </a:r>
                <a:r>
                  <a:rPr lang="hu-HU" sz="762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hu-HU" sz="762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etyltransferase</a:t>
                </a:r>
                <a:endParaRPr lang="hu-HU" sz="762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21" name="Csoportba foglalás 220"/>
            <p:cNvGrpSpPr/>
            <p:nvPr/>
          </p:nvGrpSpPr>
          <p:grpSpPr>
            <a:xfrm>
              <a:off x="4321053" y="3528465"/>
              <a:ext cx="1220771" cy="326884"/>
              <a:chOff x="7113966" y="5632597"/>
              <a:chExt cx="2563336" cy="686381"/>
            </a:xfrm>
          </p:grpSpPr>
          <p:sp>
            <p:nvSpPr>
              <p:cNvPr id="222" name="Lekerekített téglalap 221"/>
              <p:cNvSpPr/>
              <p:nvPr/>
            </p:nvSpPr>
            <p:spPr>
              <a:xfrm>
                <a:off x="7194885" y="5643154"/>
                <a:ext cx="2341002" cy="637329"/>
              </a:xfrm>
              <a:prstGeom prst="roundRect">
                <a:avLst/>
              </a:prstGeom>
              <a:solidFill>
                <a:schemeClr val="bg1">
                  <a:lumMod val="95000"/>
                </a:schemeClr>
              </a:solidFill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762"/>
              </a:p>
            </p:txBody>
          </p:sp>
          <p:sp>
            <p:nvSpPr>
              <p:cNvPr id="223" name="Szövegdoboz 222"/>
              <p:cNvSpPr txBox="1"/>
              <p:nvPr/>
            </p:nvSpPr>
            <p:spPr>
              <a:xfrm>
                <a:off x="7113966" y="5632597"/>
                <a:ext cx="2563336" cy="6863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u-HU" sz="762" b="1" u="sng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k</a:t>
                </a:r>
                <a:endParaRPr lang="hu-HU" sz="762" b="1" u="sng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hu-HU" sz="762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etate</a:t>
                </a:r>
                <a:r>
                  <a:rPr lang="hu-HU" sz="762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hu-HU" sz="762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inase</a:t>
                </a:r>
                <a:endParaRPr lang="hu-HU" sz="762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24" name="Szövegdoboz 223"/>
            <p:cNvSpPr txBox="1"/>
            <p:nvPr/>
          </p:nvSpPr>
          <p:spPr>
            <a:xfrm>
              <a:off x="5611638" y="3567488"/>
              <a:ext cx="587312" cy="3268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sz="76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cetyl-phosphate</a:t>
              </a:r>
              <a:endParaRPr lang="hu-HU" sz="76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27" name="Egyenes összekötő nyíllal 226"/>
            <p:cNvCxnSpPr/>
            <p:nvPr/>
          </p:nvCxnSpPr>
          <p:spPr>
            <a:xfrm>
              <a:off x="5524286" y="3699699"/>
              <a:ext cx="111451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8" name="Egyenes összekötő nyíllal 227"/>
            <p:cNvCxnSpPr/>
            <p:nvPr/>
          </p:nvCxnSpPr>
          <p:spPr>
            <a:xfrm>
              <a:off x="6128328" y="3691094"/>
              <a:ext cx="111451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Egyenes összekötő nyíllal 16"/>
            <p:cNvCxnSpPr/>
            <p:nvPr/>
          </p:nvCxnSpPr>
          <p:spPr>
            <a:xfrm>
              <a:off x="7423555" y="3873375"/>
              <a:ext cx="537622" cy="30402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9" name="Egyenes összekötő nyíllal 228"/>
            <p:cNvCxnSpPr/>
            <p:nvPr/>
          </p:nvCxnSpPr>
          <p:spPr>
            <a:xfrm flipV="1">
              <a:off x="4992893" y="3876435"/>
              <a:ext cx="0" cy="43518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Egyenes összekötő 23"/>
            <p:cNvCxnSpPr>
              <a:endCxn id="217" idx="1"/>
            </p:cNvCxnSpPr>
            <p:nvPr/>
          </p:nvCxnSpPr>
          <p:spPr>
            <a:xfrm>
              <a:off x="4992893" y="4311622"/>
              <a:ext cx="695389" cy="2418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0757419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56</Words>
  <Application>Microsoft Office PowerPoint</Application>
  <PresentationFormat>Szélesvásznú</PresentationFormat>
  <Paragraphs>36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éma</vt:lpstr>
      <vt:lpstr>PowerPoint bemutat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Kovács Kornél</dc:creator>
  <cp:lastModifiedBy>Kovács Kornél</cp:lastModifiedBy>
  <cp:revision>4</cp:revision>
  <dcterms:created xsi:type="dcterms:W3CDTF">2021-03-22T10:27:17Z</dcterms:created>
  <dcterms:modified xsi:type="dcterms:W3CDTF">2021-06-16T07:29:52Z</dcterms:modified>
</cp:coreProperties>
</file>